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16AAE9-8098-4849-9F96-C65ADF09EBA3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F27D3B-DDBE-4499-91EE-77DED74B9E63}" type="slidenum"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05075-1A4B-4AE8-BD09-C09AECBC12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CCF46-DC3B-4C45-88E5-AF13616895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9DCD7-476A-4C80-993B-39939C202F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67602-8DBA-45F0-9D43-2418080DBF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B4367-B4F6-4B9A-AE5A-C1388EB0B7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DE8B1-D62B-4E0B-9026-B4C4880457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B6A7B-82E2-4F12-9BAB-B361AF105A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41A2C-CDA0-4F6C-A5F8-B96B23BBEF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81852-CCC2-4481-BC79-C7ACDCC3E6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EF342-8B8A-46EA-9B3C-9106794DA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BFFCE-3837-4D85-9539-0D84359720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3C8B4-B0E9-4106-A87D-CD0F281792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marL="365040" indent="-36504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93800" indent="-30492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220760" indent="-24300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709640" indent="-24264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0000"/>
            <a:ext cx="217152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25AEA7-0604-48B9-8100-DFC542CF7E60}" type="slidenum">
              <a:rPr b="0" lang="fr-FR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1" descr="C:\Users\10013949\bioMérieux SA\OneDrive - bioMérieux SA\Projet ET model et HERV\First paper_HERV et ET model\Redaction first paper version\Fichier_figure papier 1 v2\Supplementary Figure 1\Supplementary Figure 1 CVs0.1_rep_toomany.png"/>
          <p:cNvPicPr/>
          <p:nvPr/>
        </p:nvPicPr>
        <p:blipFill>
          <a:blip r:embed="rId1"/>
          <a:srcRect l="1255" t="2423" r="7022" b="1921"/>
          <a:stretch/>
        </p:blipFill>
        <p:spPr>
          <a:xfrm>
            <a:off x="203040" y="530280"/>
            <a:ext cx="5291280" cy="312732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"/>
          <p:cNvSpPr/>
          <p:nvPr/>
        </p:nvSpPr>
        <p:spPr>
          <a:xfrm>
            <a:off x="5522760" y="504720"/>
            <a:ext cx="1293840" cy="33354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4"/>
          <p:cNvSpPr/>
          <p:nvPr/>
        </p:nvSpPr>
        <p:spPr>
          <a:xfrm>
            <a:off x="5584680" y="919080"/>
            <a:ext cx="92160" cy="193680"/>
          </a:xfrm>
          <a:prstGeom prst="rect">
            <a:avLst/>
          </a:prstGeom>
          <a:solidFill>
            <a:srgbClr val="ff996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5"/>
          <p:cNvSpPr/>
          <p:nvPr/>
        </p:nvSpPr>
        <p:spPr>
          <a:xfrm>
            <a:off x="5653080" y="893880"/>
            <a:ext cx="10922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HERV-Dfa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6"/>
          <p:cNvSpPr/>
          <p:nvPr/>
        </p:nvSpPr>
        <p:spPr>
          <a:xfrm>
            <a:off x="5584680" y="1251000"/>
            <a:ext cx="92160" cy="195120"/>
          </a:xfrm>
          <a:prstGeom prst="rect">
            <a:avLst/>
          </a:prstGeom>
          <a:solidFill>
            <a:srgbClr val="99cc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ZoneTexte 7"/>
          <p:cNvSpPr/>
          <p:nvPr/>
        </p:nvSpPr>
        <p:spPr>
          <a:xfrm>
            <a:off x="5653080" y="1227240"/>
            <a:ext cx="15922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HERV-prototyp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8"/>
          <p:cNvSpPr/>
          <p:nvPr/>
        </p:nvSpPr>
        <p:spPr>
          <a:xfrm>
            <a:off x="5584680" y="1563840"/>
            <a:ext cx="92160" cy="195120"/>
          </a:xfrm>
          <a:prstGeom prst="rect">
            <a:avLst/>
          </a:prstGeom>
          <a:solidFill>
            <a:srgbClr val="00b05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9"/>
          <p:cNvSpPr/>
          <p:nvPr/>
        </p:nvSpPr>
        <p:spPr>
          <a:xfrm>
            <a:off x="5640480" y="1546200"/>
            <a:ext cx="77940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HTA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0"/>
          <p:cNvSpPr/>
          <p:nvPr/>
        </p:nvSpPr>
        <p:spPr>
          <a:xfrm>
            <a:off x="5592600" y="581040"/>
            <a:ext cx="90720" cy="193680"/>
          </a:xfrm>
          <a:prstGeom prst="rect">
            <a:avLst/>
          </a:prstGeom>
          <a:solidFill>
            <a:srgbClr val="ff7c8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ZoneTexte 11"/>
          <p:cNvSpPr/>
          <p:nvPr/>
        </p:nvSpPr>
        <p:spPr>
          <a:xfrm>
            <a:off x="5661000" y="558720"/>
            <a:ext cx="11095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Centromeri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2"/>
          <p:cNvSpPr/>
          <p:nvPr/>
        </p:nvSpPr>
        <p:spPr>
          <a:xfrm>
            <a:off x="5592600" y="1920960"/>
            <a:ext cx="90720" cy="193680"/>
          </a:xfrm>
          <a:prstGeom prst="rect">
            <a:avLst/>
          </a:prstGeom>
          <a:solidFill>
            <a:srgbClr val="00cc9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ZoneTexte 13"/>
          <p:cNvSpPr/>
          <p:nvPr/>
        </p:nvSpPr>
        <p:spPr>
          <a:xfrm>
            <a:off x="5638680" y="1897200"/>
            <a:ext cx="77796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LINEs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5586480" y="2232000"/>
            <a:ext cx="90360" cy="195120"/>
          </a:xfrm>
          <a:prstGeom prst="rect">
            <a:avLst/>
          </a:prstGeom>
          <a:solidFill>
            <a:srgbClr val="66ff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15"/>
          <p:cNvSpPr/>
          <p:nvPr/>
        </p:nvSpPr>
        <p:spPr>
          <a:xfrm>
            <a:off x="5659560" y="2216160"/>
            <a:ext cx="77940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lncRNA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16"/>
          <p:cNvSpPr/>
          <p:nvPr/>
        </p:nvSpPr>
        <p:spPr>
          <a:xfrm>
            <a:off x="5595840" y="2565360"/>
            <a:ext cx="90720" cy="193680"/>
          </a:xfrm>
          <a:prstGeom prst="rect">
            <a:avLst/>
          </a:prstGeom>
          <a:solidFill>
            <a:srgbClr val="00b0f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ZoneTexte 17"/>
          <p:cNvSpPr/>
          <p:nvPr/>
        </p:nvSpPr>
        <p:spPr>
          <a:xfrm>
            <a:off x="5656320" y="2538360"/>
            <a:ext cx="10634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aLR-Dfam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18"/>
          <p:cNvSpPr/>
          <p:nvPr/>
        </p:nvSpPr>
        <p:spPr>
          <a:xfrm>
            <a:off x="5592600" y="2914560"/>
            <a:ext cx="90720" cy="196920"/>
          </a:xfrm>
          <a:prstGeom prst="rect">
            <a:avLst/>
          </a:prstGeom>
          <a:solidFill>
            <a:srgbClr val="9966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19"/>
          <p:cNvSpPr/>
          <p:nvPr/>
        </p:nvSpPr>
        <p:spPr>
          <a:xfrm>
            <a:off x="5664240" y="2903400"/>
            <a:ext cx="77796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Opti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20"/>
          <p:cNvSpPr/>
          <p:nvPr/>
        </p:nvSpPr>
        <p:spPr>
          <a:xfrm>
            <a:off x="5586480" y="3227400"/>
            <a:ext cx="90360" cy="193680"/>
          </a:xfrm>
          <a:prstGeom prst="rect">
            <a:avLst/>
          </a:prstGeom>
          <a:solidFill>
            <a:srgbClr val="ff66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ZoneTexte 21"/>
          <p:cNvSpPr/>
          <p:nvPr/>
        </p:nvSpPr>
        <p:spPr>
          <a:xfrm>
            <a:off x="5670720" y="3206880"/>
            <a:ext cx="7808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U133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22"/>
          <p:cNvSpPr/>
          <p:nvPr/>
        </p:nvSpPr>
        <p:spPr>
          <a:xfrm>
            <a:off x="5595840" y="3565440"/>
            <a:ext cx="90720" cy="195480"/>
          </a:xfrm>
          <a:prstGeom prst="rect">
            <a:avLst/>
          </a:prstGeom>
          <a:solidFill>
            <a:srgbClr val="ff339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ZoneTexte 23"/>
          <p:cNvSpPr/>
          <p:nvPr/>
        </p:nvSpPr>
        <p:spPr>
          <a:xfrm>
            <a:off x="5681520" y="3513240"/>
            <a:ext cx="77796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Virus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ZoneTexte 1"/>
          <p:cNvSpPr/>
          <p:nvPr/>
        </p:nvSpPr>
        <p:spPr>
          <a:xfrm rot="16200000">
            <a:off x="-1366200" y="1951920"/>
            <a:ext cx="30160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C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ZoneTexte 25"/>
          <p:cNvSpPr/>
          <p:nvPr/>
        </p:nvSpPr>
        <p:spPr>
          <a:xfrm>
            <a:off x="2262240" y="3649680"/>
            <a:ext cx="15652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Intensity</a:t>
            </a:r>
            <a:r>
              <a:rPr b="0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26"/>
          <p:cNvSpPr/>
          <p:nvPr/>
        </p:nvSpPr>
        <p:spPr>
          <a:xfrm>
            <a:off x="58680" y="407880"/>
            <a:ext cx="6757920" cy="35766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Connecteur droit 2"/>
          <p:cNvSpPr/>
          <p:nvPr/>
        </p:nvSpPr>
        <p:spPr>
          <a:xfrm>
            <a:off x="304920" y="2741760"/>
            <a:ext cx="516384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onnecteur droit 15"/>
          <p:cNvSpPr/>
          <p:nvPr/>
        </p:nvSpPr>
        <p:spPr>
          <a:xfrm flipV="1">
            <a:off x="2293920" y="677880"/>
            <a:ext cx="0" cy="2968560"/>
          </a:xfrm>
          <a:prstGeom prst="line">
            <a:avLst/>
          </a:prstGeom>
          <a:ln w="1908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ZoneTexte 25"/>
          <p:cNvSpPr/>
          <p:nvPr/>
        </p:nvSpPr>
        <p:spPr>
          <a:xfrm>
            <a:off x="1517760" y="393840"/>
            <a:ext cx="15652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Defined threeshold</a:t>
            </a: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7T08:32:57Z</dcterms:created>
  <dc:creator>MOMMERT Marine</dc:creator>
  <dc:description/>
  <dc:language>en-US</dc:language>
  <cp:lastModifiedBy>MOMMERT Marine</cp:lastModifiedBy>
  <dcterms:modified xsi:type="dcterms:W3CDTF">2018-05-13T18:50:24Z</dcterms:modified>
  <cp:revision>10</cp:revision>
  <dc:subject/>
  <dc:title>Présentation PowerPoint</dc:title>
</cp:coreProperties>
</file>